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659" autoAdjust="0"/>
  </p:normalViewPr>
  <p:slideViewPr>
    <p:cSldViewPr snapToGrid="0" snapToObjects="1">
      <p:cViewPr>
        <p:scale>
          <a:sx n="100" d="100"/>
          <a:sy n="100" d="100"/>
        </p:scale>
        <p:origin x="-1064" y="-96"/>
      </p:cViewPr>
      <p:guideLst>
        <p:guide orient="horz" pos="195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273F-F4BC-4C44-9788-34192E244855}" type="datetimeFigureOut">
              <a:rPr lang="en-US" smtClean="0"/>
              <a:t>9/26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F143A-5920-AB45-A74D-05287F4F46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613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9F143A-5920-AB45-A74D-05287F4F46A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734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982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51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116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702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560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737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38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08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376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24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08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96BE3-420F-8F41-9769-130A60F9F022}" type="datetimeFigureOut">
              <a:rPr lang="en-US" smtClean="0"/>
              <a:t>9/26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078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1" Type="http://schemas.openxmlformats.org/officeDocument/2006/relationships/slideLayout" Target="../slideLayouts/slideLayout6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44511" y="21289"/>
            <a:ext cx="6826670" cy="6112463"/>
            <a:chOff x="944511" y="757889"/>
            <a:chExt cx="6826670" cy="6112463"/>
          </a:xfrm>
        </p:grpSpPr>
        <p:pic>
          <p:nvPicPr>
            <p:cNvPr id="4" name="Picture 3" descr="Distribution.of.motif-0516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2514" r="53068"/>
            <a:stretch/>
          </p:blipFill>
          <p:spPr>
            <a:xfrm>
              <a:off x="1169097" y="3830914"/>
              <a:ext cx="3003998" cy="3039438"/>
            </a:xfrm>
            <a:prstGeom prst="rect">
              <a:avLst/>
            </a:prstGeom>
          </p:spPr>
        </p:pic>
        <p:pic>
          <p:nvPicPr>
            <p:cNvPr id="3" name="Picture 2" descr="Distribution.of.motif-0516.pdf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97" r="53068" b="52231"/>
            <a:stretch/>
          </p:blipFill>
          <p:spPr>
            <a:xfrm>
              <a:off x="4767182" y="769227"/>
              <a:ext cx="3003998" cy="2884983"/>
            </a:xfrm>
            <a:prstGeom prst="rect">
              <a:avLst/>
            </a:prstGeom>
          </p:spPr>
        </p:pic>
        <p:pic>
          <p:nvPicPr>
            <p:cNvPr id="5" name="Picture 4" descr="Distribution.of.motif-0516.pdf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06" t="2697" b="52231"/>
            <a:stretch/>
          </p:blipFill>
          <p:spPr>
            <a:xfrm>
              <a:off x="1169097" y="757889"/>
              <a:ext cx="3187197" cy="2884983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5354249" y="3994962"/>
              <a:ext cx="2416932" cy="2516643"/>
              <a:chOff x="950944" y="668659"/>
              <a:chExt cx="2548570" cy="2773294"/>
            </a:xfrm>
          </p:grpSpPr>
          <p:grpSp>
            <p:nvGrpSpPr>
              <p:cNvPr id="7" name="Group 6"/>
              <p:cNvGrpSpPr/>
              <p:nvPr/>
            </p:nvGrpSpPr>
            <p:grpSpPr>
              <a:xfrm>
                <a:off x="950944" y="950710"/>
                <a:ext cx="2548570" cy="2491243"/>
                <a:chOff x="2535494" y="386381"/>
                <a:chExt cx="3856664" cy="3719310"/>
              </a:xfrm>
            </p:grpSpPr>
            <p:sp>
              <p:nvSpPr>
                <p:cNvPr id="18" name="Oval 17"/>
                <p:cNvSpPr/>
                <p:nvPr/>
              </p:nvSpPr>
              <p:spPr>
                <a:xfrm>
                  <a:off x="2535494" y="386381"/>
                  <a:ext cx="2371593" cy="2377940"/>
                </a:xfrm>
                <a:prstGeom prst="ellipse">
                  <a:avLst/>
                </a:prstGeom>
                <a:solidFill>
                  <a:srgbClr val="FFFF00">
                    <a:alpha val="12000"/>
                  </a:srgbClr>
                </a:solidFill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9" name="Oval 18"/>
                <p:cNvSpPr/>
                <p:nvPr/>
              </p:nvSpPr>
              <p:spPr>
                <a:xfrm>
                  <a:off x="4020565" y="386381"/>
                  <a:ext cx="2371593" cy="2377940"/>
                </a:xfrm>
                <a:prstGeom prst="ellipse">
                  <a:avLst/>
                </a:prstGeom>
                <a:solidFill>
                  <a:schemeClr val="accent6">
                    <a:lumMod val="75000"/>
                    <a:alpha val="12000"/>
                  </a:schemeClr>
                </a:solidFill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20" name="Oval 19"/>
                <p:cNvSpPr/>
                <p:nvPr/>
              </p:nvSpPr>
              <p:spPr>
                <a:xfrm>
                  <a:off x="2535494" y="1329717"/>
                  <a:ext cx="3856662" cy="2775974"/>
                </a:xfrm>
                <a:prstGeom prst="ellipse">
                  <a:avLst/>
                </a:prstGeom>
                <a:solidFill>
                  <a:schemeClr val="tx2">
                    <a:lumMod val="40000"/>
                    <a:lumOff val="60000"/>
                    <a:alpha val="12000"/>
                  </a:schemeClr>
                </a:solidFill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1257124" y="668659"/>
                <a:ext cx="942911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Nova.500bp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341018" y="679998"/>
                <a:ext cx="902811" cy="276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Pum.500bp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732793" y="3095302"/>
                <a:ext cx="904099" cy="3052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PTB.200bp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1996261" y="1849177"/>
                <a:ext cx="4186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320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052311" y="1213237"/>
                <a:ext cx="3406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52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464589" y="2060698"/>
                <a:ext cx="4966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3584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309598" y="2055803"/>
                <a:ext cx="4966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2402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185805" y="1194207"/>
                <a:ext cx="4186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277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676154" y="1213237"/>
                <a:ext cx="4186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679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922179" y="2635827"/>
                <a:ext cx="574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25436</a:t>
                </a:r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944511" y="769227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A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69911" y="3818214"/>
              <a:ext cx="2932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C</a:t>
              </a:r>
              <a:endParaRPr lang="en-US" sz="1200" dirty="0" smtClean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590737" y="769227"/>
              <a:ext cx="2996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B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724952" y="3834314"/>
              <a:ext cx="3140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D</a:t>
              </a: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101600" y="5943252"/>
            <a:ext cx="9144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S5. Distribution of RNA-binding protein motifs in potato </a:t>
            </a:r>
            <a:r>
              <a:rPr lang="en-US" sz="1100" b="1" dirty="0" err="1"/>
              <a:t>transcriptome</a:t>
            </a:r>
            <a:r>
              <a:rPr lang="en-US" sz="1100" b="1" dirty="0"/>
              <a:t>. </a:t>
            </a:r>
            <a:r>
              <a:rPr lang="en-US" sz="1100" dirty="0"/>
              <a:t>The position weight matrices for Nova and </a:t>
            </a:r>
            <a:r>
              <a:rPr lang="en-US" sz="1100" dirty="0" err="1"/>
              <a:t>Pumilio</a:t>
            </a:r>
            <a:r>
              <a:rPr lang="en-US" sz="1100" dirty="0"/>
              <a:t> motifs were obtained from Jiang et al [64]. We searched the entire potato genome for the presence of these motifs using MEME suite [68]. Because the exact length of the UTR is</a:t>
            </a:r>
            <a:r>
              <a:rPr lang="en-US" sz="1100" b="1" dirty="0"/>
              <a:t> </a:t>
            </a:r>
            <a:r>
              <a:rPr lang="en-US" sz="1100" dirty="0"/>
              <a:t>currently unavailable, we chose an arbitrary fixed length of 1000 </a:t>
            </a:r>
            <a:r>
              <a:rPr lang="en-US" sz="1100" dirty="0" err="1"/>
              <a:t>nt</a:t>
            </a:r>
            <a:r>
              <a:rPr lang="en-US" sz="1100" dirty="0"/>
              <a:t> for the </a:t>
            </a:r>
            <a:r>
              <a:rPr lang="en-US" sz="1100" dirty="0" smtClean="0"/>
              <a:t>UTRs (A-C). </a:t>
            </a:r>
            <a:r>
              <a:rPr lang="en-US" sz="1100" dirty="0"/>
              <a:t>For each gene, the 1000 </a:t>
            </a:r>
            <a:r>
              <a:rPr lang="en-US" sz="1100" dirty="0" err="1"/>
              <a:t>bp</a:t>
            </a:r>
            <a:r>
              <a:rPr lang="en-US" sz="1100" dirty="0"/>
              <a:t> region downstream from the end of the coding sequence was considered as its 3´ UTR in this analysis. Using the '</a:t>
            </a:r>
            <a:r>
              <a:rPr lang="en-US" sz="1100" dirty="0" err="1"/>
              <a:t>intersectBed</a:t>
            </a:r>
            <a:r>
              <a:rPr lang="en-US" sz="1100" dirty="0"/>
              <a:t>' tool (</a:t>
            </a:r>
            <a:r>
              <a:rPr lang="en-US" sz="1100" dirty="0" err="1"/>
              <a:t>BEDTools</a:t>
            </a:r>
            <a:r>
              <a:rPr lang="en-US" sz="1100" dirty="0"/>
              <a:t> v2.18.2) [69], we extracted the genes containing </a:t>
            </a:r>
            <a:r>
              <a:rPr lang="en-US" sz="1100" dirty="0" smtClean="0"/>
              <a:t>Nova, </a:t>
            </a:r>
            <a:r>
              <a:rPr lang="en-US" sz="1100" dirty="0" err="1" smtClean="0"/>
              <a:t>Pumilio</a:t>
            </a:r>
            <a:r>
              <a:rPr lang="en-US" sz="1100" dirty="0" smtClean="0"/>
              <a:t>, or PTB </a:t>
            </a:r>
            <a:r>
              <a:rPr lang="en-US" sz="1100" dirty="0"/>
              <a:t>motifs in their 3´ </a:t>
            </a:r>
            <a:r>
              <a:rPr lang="en-US" sz="1100" dirty="0" smtClean="0"/>
              <a:t>UTRs (D).</a:t>
            </a:r>
            <a:r>
              <a:rPr lang="en-US" sz="1100" dirty="0"/>
              <a:t> </a:t>
            </a:r>
          </a:p>
          <a:p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2995778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1</TotalTime>
  <Words>81</Words>
  <Application>Microsoft Macintosh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Tian Lin</dc:creator>
  <cp:lastModifiedBy/>
  <cp:revision>25</cp:revision>
  <dcterms:created xsi:type="dcterms:W3CDTF">2014-05-27T17:03:52Z</dcterms:created>
  <dcterms:modified xsi:type="dcterms:W3CDTF">2014-09-26T19:51:06Z</dcterms:modified>
</cp:coreProperties>
</file>